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72" y="-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l-PL" smtClean="0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7711A-40DF-4A72-8668-78289FCF9260}" type="datetimeFigureOut">
              <a:rPr lang="pl-PL" smtClean="0"/>
              <a:t>2018-07-1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981F6-8FD1-4F9F-991C-0440238A4A9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625874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7711A-40DF-4A72-8668-78289FCF9260}" type="datetimeFigureOut">
              <a:rPr lang="pl-PL" smtClean="0"/>
              <a:t>2018-07-1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981F6-8FD1-4F9F-991C-0440238A4A9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20627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7711A-40DF-4A72-8668-78289FCF9260}" type="datetimeFigureOut">
              <a:rPr lang="pl-PL" smtClean="0"/>
              <a:t>2018-07-1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981F6-8FD1-4F9F-991C-0440238A4A9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796063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7711A-40DF-4A72-8668-78289FCF9260}" type="datetimeFigureOut">
              <a:rPr lang="pl-PL" smtClean="0"/>
              <a:t>2018-07-1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981F6-8FD1-4F9F-991C-0440238A4A9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908648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7711A-40DF-4A72-8668-78289FCF9260}" type="datetimeFigureOut">
              <a:rPr lang="pl-PL" smtClean="0"/>
              <a:t>2018-07-1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981F6-8FD1-4F9F-991C-0440238A4A9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752150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7711A-40DF-4A72-8668-78289FCF9260}" type="datetimeFigureOut">
              <a:rPr lang="pl-PL" smtClean="0"/>
              <a:t>2018-07-13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981F6-8FD1-4F9F-991C-0440238A4A9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734591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7711A-40DF-4A72-8668-78289FCF9260}" type="datetimeFigureOut">
              <a:rPr lang="pl-PL" smtClean="0"/>
              <a:t>2018-07-13</a:t>
            </a:fld>
            <a:endParaRPr lang="pl-P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981F6-8FD1-4F9F-991C-0440238A4A9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897350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7711A-40DF-4A72-8668-78289FCF9260}" type="datetimeFigureOut">
              <a:rPr lang="pl-PL" smtClean="0"/>
              <a:t>2018-07-13</a:t>
            </a:fld>
            <a:endParaRPr lang="pl-P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981F6-8FD1-4F9F-991C-0440238A4A9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798995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7711A-40DF-4A72-8668-78289FCF9260}" type="datetimeFigureOut">
              <a:rPr lang="pl-PL" smtClean="0"/>
              <a:t>2018-07-13</a:t>
            </a:fld>
            <a:endParaRPr lang="pl-P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981F6-8FD1-4F9F-991C-0440238A4A9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80754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7711A-40DF-4A72-8668-78289FCF9260}" type="datetimeFigureOut">
              <a:rPr lang="pl-PL" smtClean="0"/>
              <a:t>2018-07-13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981F6-8FD1-4F9F-991C-0440238A4A9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636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l-PL" smtClean="0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7711A-40DF-4A72-8668-78289FCF9260}" type="datetimeFigureOut">
              <a:rPr lang="pl-PL" smtClean="0"/>
              <a:t>2018-07-13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981F6-8FD1-4F9F-991C-0440238A4A9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31697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77711A-40DF-4A72-8668-78289FCF9260}" type="datetimeFigureOut">
              <a:rPr lang="pl-PL" smtClean="0"/>
              <a:t>2018-07-1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1981F6-8FD1-4F9F-991C-0440238A4A9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55013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Obraz 15"/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975" y="2680275"/>
            <a:ext cx="1980000" cy="1980000"/>
          </a:xfrm>
          <a:prstGeom prst="rect">
            <a:avLst/>
          </a:prstGeom>
        </p:spPr>
      </p:pic>
      <p:grpSp>
        <p:nvGrpSpPr>
          <p:cNvPr id="8" name="Grupa 7"/>
          <p:cNvGrpSpPr/>
          <p:nvPr/>
        </p:nvGrpSpPr>
        <p:grpSpPr>
          <a:xfrm>
            <a:off x="363285" y="663224"/>
            <a:ext cx="6115891" cy="3997051"/>
            <a:chOff x="563470" y="1090287"/>
            <a:chExt cx="6771163" cy="4425306"/>
          </a:xfrm>
        </p:grpSpPr>
        <p:pic>
          <p:nvPicPr>
            <p:cNvPr id="2" name="Obraz 1" descr="D:\Dropbox\Zdjęcia\astrocyty\glej 29.10.jpg">
              <a:extLst>
                <a:ext uri="{FF2B5EF4-FFF2-40B4-BE49-F238E27FC236}">
                  <a16:creationId xmlns:a16="http://schemas.microsoft.com/office/drawing/2014/main" xmlns="" id="{0A1D1B26-3626-438A-9699-812655CB3F4D}"/>
                </a:ext>
              </a:extLst>
            </p:cNvPr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3470" y="1092994"/>
              <a:ext cx="2193750" cy="219375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" name="Obraz 3" descr="C:\Users\Konrad\Desktop\Glej\Captured 5.jpg">
              <a:extLst>
                <a:ext uri="{FF2B5EF4-FFF2-40B4-BE49-F238E27FC236}">
                  <a16:creationId xmlns:a16="http://schemas.microsoft.com/office/drawing/2014/main" xmlns="" id="{CD393A22-2046-4833-8BCE-A3A7B046AEA3}"/>
                </a:ext>
              </a:extLst>
            </p:cNvPr>
            <p:cNvPicPr/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40883" y="1090287"/>
              <a:ext cx="2193750" cy="219375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" name="Obraz 4" descr="C:\Users\Konrad\AppData\Local\Microsoft\Windows\INetCache\Content.Word\Captured 10.jpg">
              <a:extLst>
                <a:ext uri="{FF2B5EF4-FFF2-40B4-BE49-F238E27FC236}">
                  <a16:creationId xmlns:a16="http://schemas.microsoft.com/office/drawing/2014/main" xmlns="" id="{97D4181E-BF68-4353-AFEC-B056371DE15D}"/>
                </a:ext>
              </a:extLst>
            </p:cNvPr>
            <p:cNvPicPr/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40883" y="3321843"/>
              <a:ext cx="2193750" cy="219375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6" name="Obraz 5">
              <a:extLst>
                <a:ext uri="{FF2B5EF4-FFF2-40B4-BE49-F238E27FC236}">
                  <a16:creationId xmlns:a16="http://schemas.microsoft.com/office/drawing/2014/main" xmlns="" id="{6D64E58B-4E51-4C7B-9696-8EEC356BE0DE}"/>
                </a:ext>
              </a:extLst>
            </p:cNvPr>
            <p:cNvPicPr/>
            <p:nvPr/>
          </p:nvPicPr>
          <p:blipFill>
            <a:blip r:embed="rId6"/>
            <a:stretch>
              <a:fillRect/>
            </a:stretch>
          </p:blipFill>
          <p:spPr>
            <a:xfrm rot="5400000">
              <a:off x="2857082" y="3321843"/>
              <a:ext cx="2193750" cy="2193750"/>
            </a:xfrm>
            <a:prstGeom prst="rect">
              <a:avLst/>
            </a:prstGeom>
          </p:spPr>
        </p:pic>
        <p:pic>
          <p:nvPicPr>
            <p:cNvPr id="7" name="Obraz 6">
              <a:extLst>
                <a:ext uri="{FF2B5EF4-FFF2-40B4-BE49-F238E27FC236}">
                  <a16:creationId xmlns:a16="http://schemas.microsoft.com/office/drawing/2014/main" xmlns="" id="{65C07A82-54ED-481E-AC30-6C3C613C88B0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852176" y="1090287"/>
              <a:ext cx="2193750" cy="2193750"/>
            </a:xfrm>
            <a:prstGeom prst="rect">
              <a:avLst/>
            </a:prstGeom>
          </p:spPr>
        </p:pic>
        <p:sp>
          <p:nvSpPr>
            <p:cNvPr id="3" name="pole tekstowe 2">
              <a:extLst>
                <a:ext uri="{FF2B5EF4-FFF2-40B4-BE49-F238E27FC236}">
                  <a16:creationId xmlns:a16="http://schemas.microsoft.com/office/drawing/2014/main" xmlns="" id="{653C3364-3CEC-41C9-BDC7-06D41B4F6B72}"/>
                </a:ext>
              </a:extLst>
            </p:cNvPr>
            <p:cNvSpPr txBox="1"/>
            <p:nvPr/>
          </p:nvSpPr>
          <p:spPr>
            <a:xfrm>
              <a:off x="573880" y="1100085"/>
              <a:ext cx="212462" cy="3066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1" name="pole tekstowe 10">
              <a:extLst>
                <a:ext uri="{FF2B5EF4-FFF2-40B4-BE49-F238E27FC236}">
                  <a16:creationId xmlns:a16="http://schemas.microsoft.com/office/drawing/2014/main" xmlns="" id="{7BB121F2-304F-4903-954C-A34C8E6E5E66}"/>
                </a:ext>
              </a:extLst>
            </p:cNvPr>
            <p:cNvSpPr txBox="1"/>
            <p:nvPr/>
          </p:nvSpPr>
          <p:spPr>
            <a:xfrm>
              <a:off x="5146864" y="3321843"/>
              <a:ext cx="212462" cy="3066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12" name="pole tekstowe 11">
              <a:extLst>
                <a:ext uri="{FF2B5EF4-FFF2-40B4-BE49-F238E27FC236}">
                  <a16:creationId xmlns:a16="http://schemas.microsoft.com/office/drawing/2014/main" xmlns="" id="{AAA83ACF-A103-40A6-88C2-6D98B97B2218}"/>
                </a:ext>
              </a:extLst>
            </p:cNvPr>
            <p:cNvSpPr txBox="1"/>
            <p:nvPr/>
          </p:nvSpPr>
          <p:spPr>
            <a:xfrm>
              <a:off x="573880" y="3321843"/>
              <a:ext cx="212462" cy="3066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3" name="pole tekstowe 12">
              <a:extLst>
                <a:ext uri="{FF2B5EF4-FFF2-40B4-BE49-F238E27FC236}">
                  <a16:creationId xmlns:a16="http://schemas.microsoft.com/office/drawing/2014/main" xmlns="" id="{BE48BEF3-AEF1-424B-95C4-0B934187C6B0}"/>
                </a:ext>
              </a:extLst>
            </p:cNvPr>
            <p:cNvSpPr txBox="1"/>
            <p:nvPr/>
          </p:nvSpPr>
          <p:spPr>
            <a:xfrm>
              <a:off x="5140883" y="1090287"/>
              <a:ext cx="212462" cy="3066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pl-PL"/>
              </a:defPPr>
              <a:lvl1pPr>
                <a:defRPr sz="1013" b="1">
                  <a:solidFill>
                    <a:schemeClr val="bg1"/>
                  </a:solidFill>
                </a:defRPr>
              </a:lvl1pPr>
            </a:lstStyle>
            <a:p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14" name="pole tekstowe 13">
              <a:extLst>
                <a:ext uri="{FF2B5EF4-FFF2-40B4-BE49-F238E27FC236}">
                  <a16:creationId xmlns:a16="http://schemas.microsoft.com/office/drawing/2014/main" xmlns="" id="{AB854B27-286D-43FD-B9D6-377804011FA0}"/>
                </a:ext>
              </a:extLst>
            </p:cNvPr>
            <p:cNvSpPr txBox="1"/>
            <p:nvPr/>
          </p:nvSpPr>
          <p:spPr>
            <a:xfrm>
              <a:off x="2860372" y="3315013"/>
              <a:ext cx="212462" cy="3066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5" name="pole tekstowe 14">
              <a:extLst>
                <a:ext uri="{FF2B5EF4-FFF2-40B4-BE49-F238E27FC236}">
                  <a16:creationId xmlns:a16="http://schemas.microsoft.com/office/drawing/2014/main" xmlns="" id="{4EA10CEE-EED7-4900-A4D2-767649AB0C91}"/>
                </a:ext>
              </a:extLst>
            </p:cNvPr>
            <p:cNvSpPr txBox="1"/>
            <p:nvPr/>
          </p:nvSpPr>
          <p:spPr>
            <a:xfrm>
              <a:off x="2852176" y="1102966"/>
              <a:ext cx="212462" cy="3066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sp>
        <p:nvSpPr>
          <p:cNvPr id="9" name="Prostokąt 8"/>
          <p:cNvSpPr/>
          <p:nvPr/>
        </p:nvSpPr>
        <p:spPr>
          <a:xfrm>
            <a:off x="362641" y="5075188"/>
            <a:ext cx="6116535" cy="39703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pl-PL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Supplementary</a:t>
            </a:r>
            <a:r>
              <a:rPr lang="pl-PL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pl-PL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Figure</a:t>
            </a:r>
            <a:r>
              <a:rPr lang="pl-PL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pl-PL" sz="1200" dirty="0" smtClean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Th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included pictures shows: </a:t>
            </a:r>
            <a:r>
              <a:rPr lang="pl-PL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A)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living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ells (phase contrast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);</a:t>
            </a:r>
            <a:r>
              <a:rPr lang="pl-PL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B)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ells stained with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calcein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AM; </a:t>
            </a:r>
            <a:r>
              <a:rPr lang="pl-PL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D)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nuclei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ells stained with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DAPI;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,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E</a:t>
            </a:r>
            <a:r>
              <a:rPr lang="pl-PL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and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F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) and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ells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immunolabelled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for GFAP an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Neurofilamen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-L revealed pure primary astrocyte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culture</a:t>
            </a:r>
            <a:r>
              <a:rPr lang="pl-PL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</a:p>
          <a:p>
            <a:pPr algn="just"/>
            <a:endParaRPr lang="pl-PL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algn="just"/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We used primary antibodies for direct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immunolabelin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: GFAP (GA5) Mouse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mA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(Alexa Fluor® 555 Conjugate) #3656 an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Neurofilamen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-L (C28E10) Rabbit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mA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(Alexa Fluor® 488 Conjugate) #8024, antibodies were purchased from Cell Signaling Technology, Inc. </a:t>
            </a:r>
            <a:endParaRPr lang="pl-PL" sz="1200" dirty="0" smtClean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endParaRPr lang="pl-PL" sz="1200" dirty="0" smtClean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Direct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immunofluorescence staining was made according to manufacturer's protocol. Briefly: </a:t>
            </a:r>
            <a:endParaRPr lang="pl-PL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228600" lvl="0" indent="-228600"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ells growing on glass coverslips were fixed in 4% formaldehyde diluted in PBS for 15 min.</a:t>
            </a:r>
            <a:endParaRPr lang="pl-PL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228600" lvl="0" indent="-228600"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Non-specific bindings were block by blocking buffer (PBS with 5% normal goat serum and 0.3% Triton™ X-100) for 60 min.</a:t>
            </a:r>
            <a:endParaRPr lang="pl-PL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228600" lvl="0" indent="-228600"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Antibodies were diluted (dilution 1:50 according to data sheet) in antibody dilution buffer (PBS with 1% BSA and  0.3% Triton™ X-100)</a:t>
            </a:r>
            <a:endParaRPr lang="pl-PL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228600" lvl="0" indent="-228600"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After washing, the primary antibodies for GFAP an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Neurofilamen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-L were applied</a:t>
            </a:r>
            <a:endParaRPr lang="pl-PL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228600" lvl="0" indent="-228600"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ells were incubated with antibodies overnight at 4°C</a:t>
            </a:r>
            <a:endParaRPr lang="pl-PL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228600" lvl="0" indent="-228600"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After washing in PBS the coverslips were mount with a drop of mounting medium Prolong Gold with DAPI (Cell Signaling) and for long-term storage, slides were kept flat at 4°C protected from light</a:t>
            </a:r>
            <a:endParaRPr lang="pl-PL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algn="just"/>
            <a:endParaRPr lang="pl-PL" sz="1200" dirty="0"/>
          </a:p>
        </p:txBody>
      </p:sp>
    </p:spTree>
    <p:extLst>
      <p:ext uri="{BB962C8B-B14F-4D97-AF65-F5344CB8AC3E}">
        <p14:creationId xmlns:p14="http://schemas.microsoft.com/office/powerpoint/2010/main" val="28086559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</TotalTime>
  <Words>123</Words>
  <Application>Microsoft Office PowerPoint</Application>
  <PresentationFormat>Papier A4 (210x297 mm)</PresentationFormat>
  <Paragraphs>18</Paragraphs>
  <Slides>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4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Motyw pakietu Office</vt:lpstr>
      <vt:lpstr>Prezentacja programu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AW</dc:creator>
  <cp:lastModifiedBy>Konrad Szychowski</cp:lastModifiedBy>
  <cp:revision>17</cp:revision>
  <dcterms:created xsi:type="dcterms:W3CDTF">2018-07-13T07:22:32Z</dcterms:created>
  <dcterms:modified xsi:type="dcterms:W3CDTF">2018-07-13T11:04:31Z</dcterms:modified>
</cp:coreProperties>
</file>